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3" d="100"/>
          <a:sy n="83" d="100"/>
        </p:scale>
        <p:origin x="6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2C31E9-F7C1-4FBC-929A-9C6C95F3EFF6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E7EA7-EAE0-4EF8-BD62-3833E1240B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3494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9602E-A4C4-24FA-CAA6-0A2DB761E3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E67A04-2440-9D03-5154-5EF631DA11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D4729-31FD-4721-93FF-80CFDA79F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14507F-49CA-00D9-D44D-BBE269647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BC1A2-EAB4-86B2-28A5-7C86B7D92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191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6DF6F-A669-EDE1-BACE-3861AF7D1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5626EB-667A-BD12-783C-622E327321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A48960-92C9-C88D-A5E9-9CA26925E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7887A-486F-96DB-E252-E771C60C2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EF4EA-5884-21F9-FCE4-063152322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829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D09595-2C96-9E78-82B9-90855C243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41F7B1-2608-1BF6-227E-88D7B83FC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4FF9C3-F086-3473-178B-35E11B57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DC9B22-BD2E-8A60-A1BE-96B99CE69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4A34CD-B8B0-B335-0CA1-BAE6826AD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9244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3CDF8-4E03-DFD1-70DA-8C7123BD0F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0A9E4B-DE5E-09FB-FE23-49C767C6A4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45771-96C0-BE74-0715-223F1461B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B314CC-6F8C-D5CE-EA39-66C321504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AD5F50-6E7B-7A0C-DA5E-F740EE309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516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A5373-1019-5F69-549E-9D106DD79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453FED-B923-E700-531C-6AA985B71C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2C3908-DECE-BFBB-9ECF-9794E5C0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A6C336-8069-DD5F-4060-6EE293D7C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899383-B9E2-AD36-C849-4B4737CE8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428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842CC-A530-4DB1-8676-4E283DB37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3AAF6D-3B58-B809-5F06-A4DF7F6221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E3304A-87A4-9812-360C-5F818B4C50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250F09-9AF9-DA77-D1B8-FC40815FE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C4E812-CDA3-6FBB-D6EB-2A9774394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A03AD2-EA31-2C75-B15C-912B4C6A7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144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542B32-F7EE-3664-6616-F46C07CB8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2E10C2-582E-6BF6-F09E-8E6C6593E7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54654F-C5F2-C416-EE2E-F3B5167018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C325E8-9DFC-EEDF-80D9-CB816754EC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6B450D-84C6-3D77-5D28-12DE859BE7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298CA8-8628-5B6E-32D3-78686FF0B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F13E68-21BE-5D73-7F30-7DA4CBC29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84A97A-FD30-80F3-482B-8EE98F243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697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84597-01DF-19D2-C7A4-F0510DE8F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A5F73D-181E-40B6-1B81-6D99C5B33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320DCC-4907-1F12-7763-0694C661B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5ADA21-0F74-469A-83DB-245898A83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449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0B9746-141D-C5B0-C650-CF049CEA6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53A3A4-AB49-AC4D-96D4-89C13661E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03D0B0-B95A-64A3-9586-0E0285035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6059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4FBB95-2E2A-7E0F-65BC-AAA20C5B8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471E02-E09C-F0FA-5EE4-3F8FBB7FC3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4B7179-1F6E-CF44-401E-91D516A156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AB82D6-FE8A-FE4B-D2D4-0E5CF712E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A4C502-A346-0DB5-130E-97394D8C7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48C973-2753-DC67-3D04-18C430FA6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1845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E1429-0969-4CB7-2CD3-3E795F1D5A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701B2E-0361-4620-CB09-70D9093028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F0C88E-31C4-EDAC-1EE3-070CCD10F0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17CB5B-B2BC-EA12-B95D-90F842627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2588C4-1B0A-2D65-2F3D-847FA379E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03EE43-25AE-4073-E07F-DD10AC8FB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6036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DA57AB-4BA8-2BED-502D-D4CD56F4C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FC139C-631D-DB90-7137-E71D9F152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6B2D8F-A76F-D93A-290E-4F835C8F3C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373F9C-5CC3-4D8C-89DC-5BC0924AFC10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7C2C1C-F19D-DB94-0E48-FC5E36C7C5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6D2A7-3850-4917-F595-813F5F8600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8E8DDD-50F7-4811-A182-797204C4DA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757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833B9F-DFA2-BE5E-65DE-FC843A159502}"/>
              </a:ext>
            </a:extLst>
          </p:cNvPr>
          <p:cNvSpPr txBox="1"/>
          <p:nvPr/>
        </p:nvSpPr>
        <p:spPr>
          <a:xfrm>
            <a:off x="0" y="0"/>
            <a:ext cx="19447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HT29_biological replicate_n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CA02209-0450-24F6-8FF2-794080C4E4F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26" t="252" r="282" b="-853"/>
          <a:stretch/>
        </p:blipFill>
        <p:spPr>
          <a:xfrm>
            <a:off x="326116" y="423656"/>
            <a:ext cx="4886464" cy="2892056"/>
          </a:xfrm>
          <a:prstGeom prst="rect">
            <a:avLst/>
          </a:prstGeom>
          <a:ln w="6350"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2D7B796-F17F-4C68-A0AB-63166A1993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-226" t="-893" r="-490" b="89"/>
          <a:stretch/>
        </p:blipFill>
        <p:spPr>
          <a:xfrm>
            <a:off x="533577" y="3486864"/>
            <a:ext cx="4679003" cy="2947480"/>
          </a:xfrm>
          <a:prstGeom prst="rect">
            <a:avLst/>
          </a:prstGeom>
          <a:ln w="6350"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DAF9E70-7490-62B3-28B3-3C52309AF93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/>
          <a:srcRect l="-38" t="-1642" r="24" b="-561"/>
          <a:stretch/>
        </p:blipFill>
        <p:spPr>
          <a:xfrm>
            <a:off x="6260164" y="3486864"/>
            <a:ext cx="4435812" cy="2947480"/>
          </a:xfrm>
          <a:prstGeom prst="rect">
            <a:avLst/>
          </a:prstGeom>
          <a:ln w="6350">
            <a:noFill/>
          </a:ln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1280B39E-6267-0CF3-0542-6D4BAB311D4E}"/>
              </a:ext>
            </a:extLst>
          </p:cNvPr>
          <p:cNvSpPr/>
          <p:nvPr/>
        </p:nvSpPr>
        <p:spPr>
          <a:xfrm>
            <a:off x="1020250" y="4659046"/>
            <a:ext cx="1470913" cy="25291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B27B5D1-1DCB-4502-1D8C-A7FA7905DD69}"/>
              </a:ext>
            </a:extLst>
          </p:cNvPr>
          <p:cNvSpPr txBox="1"/>
          <p:nvPr/>
        </p:nvSpPr>
        <p:spPr>
          <a:xfrm>
            <a:off x="3274123" y="4614505"/>
            <a:ext cx="5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ATG5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EB62BD0-44E1-E5EA-992F-3B8E5E8AB545}"/>
              </a:ext>
            </a:extLst>
          </p:cNvPr>
          <p:cNvSpPr/>
          <p:nvPr/>
        </p:nvSpPr>
        <p:spPr>
          <a:xfrm>
            <a:off x="6770451" y="5058383"/>
            <a:ext cx="1410511" cy="26862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C576D3-54F2-BF89-0B10-CBBA889D6AD8}"/>
              </a:ext>
            </a:extLst>
          </p:cNvPr>
          <p:cNvSpPr txBox="1"/>
          <p:nvPr/>
        </p:nvSpPr>
        <p:spPr>
          <a:xfrm>
            <a:off x="8963922" y="4988278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C346ED6-D50E-48D8-C5EC-BD06727D27A0}"/>
              </a:ext>
            </a:extLst>
          </p:cNvPr>
          <p:cNvSpPr/>
          <p:nvPr/>
        </p:nvSpPr>
        <p:spPr>
          <a:xfrm>
            <a:off x="1943771" y="2204038"/>
            <a:ext cx="859278" cy="20428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724E39-EC81-497B-5655-D6A24859B62A}"/>
              </a:ext>
            </a:extLst>
          </p:cNvPr>
          <p:cNvSpPr txBox="1"/>
          <p:nvPr/>
        </p:nvSpPr>
        <p:spPr>
          <a:xfrm>
            <a:off x="3353468" y="216767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</p:spTree>
    <p:extLst>
      <p:ext uri="{BB962C8B-B14F-4D97-AF65-F5344CB8AC3E}">
        <p14:creationId xmlns:p14="http://schemas.microsoft.com/office/powerpoint/2010/main" val="4137309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60B1A0BC-950E-5608-0132-6C7187C3714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1" t="-716" r="-420" b="-295"/>
          <a:stretch/>
        </p:blipFill>
        <p:spPr>
          <a:xfrm>
            <a:off x="141822" y="332599"/>
            <a:ext cx="4826420" cy="3029133"/>
          </a:xfrm>
          <a:prstGeom prst="rect">
            <a:avLst/>
          </a:prstGeom>
          <a:ln w="9525"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7F2DA54-9A14-8B8A-AB10-01A62704160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-4" t="-295" r="519" b="112"/>
          <a:stretch/>
        </p:blipFill>
        <p:spPr>
          <a:xfrm>
            <a:off x="241355" y="2955141"/>
            <a:ext cx="4826421" cy="3668079"/>
          </a:xfrm>
          <a:prstGeom prst="rect">
            <a:avLst/>
          </a:prstGeom>
          <a:ln w="9525"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FFD1602-2796-FD1D-29A3-DAF95DB7466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/>
          <a:srcRect l="125" t="-1369" r="-225" b="113"/>
          <a:stretch/>
        </p:blipFill>
        <p:spPr>
          <a:xfrm>
            <a:off x="5695405" y="2955141"/>
            <a:ext cx="5559884" cy="3668079"/>
          </a:xfrm>
          <a:prstGeom prst="rect">
            <a:avLst/>
          </a:prstGeom>
          <a:ln w="9525"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756739A-12C3-E38B-3CEC-805CD3194C4F}"/>
              </a:ext>
            </a:extLst>
          </p:cNvPr>
          <p:cNvSpPr txBox="1"/>
          <p:nvPr/>
        </p:nvSpPr>
        <p:spPr>
          <a:xfrm>
            <a:off x="0" y="0"/>
            <a:ext cx="19447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HT29_biological replicate_n2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5062C11-063E-EA3C-3452-2B7C57B32D3A}"/>
              </a:ext>
            </a:extLst>
          </p:cNvPr>
          <p:cNvSpPr/>
          <p:nvPr/>
        </p:nvSpPr>
        <p:spPr>
          <a:xfrm>
            <a:off x="1084119" y="4905856"/>
            <a:ext cx="1470913" cy="25291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CEAF70-F65C-4C95-B363-CEFB831910DF}"/>
              </a:ext>
            </a:extLst>
          </p:cNvPr>
          <p:cNvSpPr txBox="1"/>
          <p:nvPr/>
        </p:nvSpPr>
        <p:spPr>
          <a:xfrm>
            <a:off x="3952875" y="4844122"/>
            <a:ext cx="5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ATG5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5460607-C66D-168B-6546-9624D3199FBE}"/>
              </a:ext>
            </a:extLst>
          </p:cNvPr>
          <p:cNvSpPr/>
          <p:nvPr/>
        </p:nvSpPr>
        <p:spPr>
          <a:xfrm>
            <a:off x="6645825" y="5121121"/>
            <a:ext cx="1662603" cy="26862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A61753-7C69-0591-F472-558764225D7E}"/>
              </a:ext>
            </a:extLst>
          </p:cNvPr>
          <p:cNvSpPr txBox="1"/>
          <p:nvPr/>
        </p:nvSpPr>
        <p:spPr>
          <a:xfrm>
            <a:off x="10069007" y="497843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26225CF-3330-AC11-5073-8245432B9746}"/>
              </a:ext>
            </a:extLst>
          </p:cNvPr>
          <p:cNvSpPr/>
          <p:nvPr/>
        </p:nvSpPr>
        <p:spPr>
          <a:xfrm>
            <a:off x="1164876" y="2024149"/>
            <a:ext cx="821178" cy="19779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5C116D6-FD98-486D-8AFF-392A47F1D979}"/>
              </a:ext>
            </a:extLst>
          </p:cNvPr>
          <p:cNvSpPr txBox="1"/>
          <p:nvPr/>
        </p:nvSpPr>
        <p:spPr>
          <a:xfrm>
            <a:off x="2766806" y="199826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</p:spTree>
    <p:extLst>
      <p:ext uri="{BB962C8B-B14F-4D97-AF65-F5344CB8AC3E}">
        <p14:creationId xmlns:p14="http://schemas.microsoft.com/office/powerpoint/2010/main" val="40559373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F9D64B9-A249-2639-36F7-8515E8B2C0DC}"/>
              </a:ext>
            </a:extLst>
          </p:cNvPr>
          <p:cNvSpPr txBox="1"/>
          <p:nvPr/>
        </p:nvSpPr>
        <p:spPr>
          <a:xfrm>
            <a:off x="0" y="0"/>
            <a:ext cx="19447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HT29_biological replicate_n3</a:t>
            </a:r>
          </a:p>
        </p:txBody>
      </p:sp>
      <p:pic>
        <p:nvPicPr>
          <p:cNvPr id="5" name="Picture 4" descr="A picture containing white, black and white, black, monochrome&#10;&#10;Description automatically generated">
            <a:extLst>
              <a:ext uri="{FF2B5EF4-FFF2-40B4-BE49-F238E27FC236}">
                <a16:creationId xmlns:a16="http://schemas.microsoft.com/office/drawing/2014/main" id="{299FA994-8568-54A7-2C44-7E1B00CDDD4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4" t="-730" r="-327" b="-2269"/>
          <a:stretch/>
        </p:blipFill>
        <p:spPr>
          <a:xfrm>
            <a:off x="31159" y="307887"/>
            <a:ext cx="5146438" cy="3121113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32233A9-8EDF-CEAC-0128-2D0EBB68D9A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l="358" t="-550" r="332" b="1605"/>
          <a:stretch/>
        </p:blipFill>
        <p:spPr bwMode="auto">
          <a:xfrm>
            <a:off x="530251" y="3635295"/>
            <a:ext cx="4148254" cy="2129883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29DDDAA-DA72-99ED-5DB1-EC6CD68A23A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55" t="127" r="-25" b="135"/>
          <a:stretch/>
        </p:blipFill>
        <p:spPr>
          <a:xfrm>
            <a:off x="6021372" y="3524575"/>
            <a:ext cx="3796881" cy="2240603"/>
          </a:xfrm>
          <a:prstGeom prst="rect">
            <a:avLst/>
          </a:prstGeom>
          <a:ln>
            <a:noFill/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ABC3DE40-8020-03AD-45F5-F00387520262}"/>
              </a:ext>
            </a:extLst>
          </p:cNvPr>
          <p:cNvSpPr/>
          <p:nvPr/>
        </p:nvSpPr>
        <p:spPr>
          <a:xfrm>
            <a:off x="2000680" y="2221765"/>
            <a:ext cx="961674" cy="23783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C2205B-A77D-432F-22B3-E8FD8481C934}"/>
              </a:ext>
            </a:extLst>
          </p:cNvPr>
          <p:cNvSpPr txBox="1"/>
          <p:nvPr/>
        </p:nvSpPr>
        <p:spPr>
          <a:xfrm>
            <a:off x="2962354" y="218260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78932F0-E9EC-A4A2-9224-80D38DFA47D3}"/>
              </a:ext>
            </a:extLst>
          </p:cNvPr>
          <p:cNvSpPr/>
          <p:nvPr/>
        </p:nvSpPr>
        <p:spPr>
          <a:xfrm>
            <a:off x="803782" y="4696337"/>
            <a:ext cx="1504519" cy="25741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0ABD4D-60EC-08E1-47CE-06F624F532B1}"/>
              </a:ext>
            </a:extLst>
          </p:cNvPr>
          <p:cNvSpPr txBox="1"/>
          <p:nvPr/>
        </p:nvSpPr>
        <p:spPr>
          <a:xfrm>
            <a:off x="2308301" y="4676755"/>
            <a:ext cx="5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ATG5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7A2C09A-3F99-77E3-680E-513033C6CA63}"/>
              </a:ext>
            </a:extLst>
          </p:cNvPr>
          <p:cNvSpPr/>
          <p:nvPr/>
        </p:nvSpPr>
        <p:spPr>
          <a:xfrm>
            <a:off x="6096000" y="4815195"/>
            <a:ext cx="1496291" cy="29245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A41EC6-3503-4F63-258F-70882303A6B9}"/>
              </a:ext>
            </a:extLst>
          </p:cNvPr>
          <p:cNvSpPr txBox="1"/>
          <p:nvPr/>
        </p:nvSpPr>
        <p:spPr>
          <a:xfrm>
            <a:off x="7592639" y="4815195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545215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3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4</cp:revision>
  <dcterms:created xsi:type="dcterms:W3CDTF">2024-08-31T23:53:17Z</dcterms:created>
  <dcterms:modified xsi:type="dcterms:W3CDTF">2024-09-01T00:09:08Z</dcterms:modified>
</cp:coreProperties>
</file>